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1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nrique María Mateu de Antonio" userId="678ddb83-0020-4a06-85d2-928a222534ef" providerId="ADAL" clId="{D4379B84-A6AD-4684-B59C-7DAD498342B1}"/>
    <pc:docChg chg="modSld">
      <pc:chgData name="Enrique María Mateu de Antonio" userId="678ddb83-0020-4a06-85d2-928a222534ef" providerId="ADAL" clId="{D4379B84-A6AD-4684-B59C-7DAD498342B1}" dt="2025-04-22T12:48:21.326" v="1" actId="2711"/>
      <pc:docMkLst>
        <pc:docMk/>
      </pc:docMkLst>
      <pc:sldChg chg="modSp mod">
        <pc:chgData name="Enrique María Mateu de Antonio" userId="678ddb83-0020-4a06-85d2-928a222534ef" providerId="ADAL" clId="{D4379B84-A6AD-4684-B59C-7DAD498342B1}" dt="2025-04-22T12:48:21.326" v="1" actId="2711"/>
        <pc:sldMkLst>
          <pc:docMk/>
          <pc:sldMk cId="2305813411" sldId="256"/>
        </pc:sldMkLst>
        <pc:spChg chg="mod">
          <ac:chgData name="Enrique María Mateu de Antonio" userId="678ddb83-0020-4a06-85d2-928a222534ef" providerId="ADAL" clId="{D4379B84-A6AD-4684-B59C-7DAD498342B1}" dt="2025-04-22T12:48:21.326" v="1" actId="2711"/>
          <ac:spMkLst>
            <pc:docMk/>
            <pc:sldMk cId="2305813411" sldId="256"/>
            <ac:spMk id="3" creationId="{F3C2BABC-2B76-A0CE-EE7E-FF586944F832}"/>
          </ac:spMkLst>
        </pc:spChg>
      </pc:sldChg>
    </pc:docChg>
  </pc:docChgLst>
  <pc:docChgLst>
    <pc:chgData name="Enrique María Mateu de Antonio" userId="678ddb83-0020-4a06-85d2-928a222534ef" providerId="ADAL" clId="{9CE11C97-1C70-4DAD-8EF4-EC47006C3E3A}"/>
    <pc:docChg chg="modSld">
      <pc:chgData name="Enrique María Mateu de Antonio" userId="678ddb83-0020-4a06-85d2-928a222534ef" providerId="ADAL" clId="{9CE11C97-1C70-4DAD-8EF4-EC47006C3E3A}" dt="2025-04-07T13:47:56.294" v="11" actId="1076"/>
      <pc:docMkLst>
        <pc:docMk/>
      </pc:docMkLst>
      <pc:sldChg chg="addSp modSp mod">
        <pc:chgData name="Enrique María Mateu de Antonio" userId="678ddb83-0020-4a06-85d2-928a222534ef" providerId="ADAL" clId="{9CE11C97-1C70-4DAD-8EF4-EC47006C3E3A}" dt="2025-04-07T13:47:56.294" v="11" actId="1076"/>
        <pc:sldMkLst>
          <pc:docMk/>
          <pc:sldMk cId="2305813411" sldId="256"/>
        </pc:sldMkLst>
        <pc:spChg chg="add mod">
          <ac:chgData name="Enrique María Mateu de Antonio" userId="678ddb83-0020-4a06-85d2-928a222534ef" providerId="ADAL" clId="{9CE11C97-1C70-4DAD-8EF4-EC47006C3E3A}" dt="2025-04-07T13:47:54.382" v="10" actId="1076"/>
          <ac:spMkLst>
            <pc:docMk/>
            <pc:sldMk cId="2305813411" sldId="256"/>
            <ac:spMk id="3" creationId="{F3C2BABC-2B76-A0CE-EE7E-FF586944F832}"/>
          </ac:spMkLst>
        </pc:spChg>
        <pc:graphicFrameChg chg="mod">
          <ac:chgData name="Enrique María Mateu de Antonio" userId="678ddb83-0020-4a06-85d2-928a222534ef" providerId="ADAL" clId="{9CE11C97-1C70-4DAD-8EF4-EC47006C3E3A}" dt="2025-04-07T13:47:56.294" v="11" actId="1076"/>
          <ac:graphicFrameMkLst>
            <pc:docMk/>
            <pc:sldMk cId="2305813411" sldId="256"/>
            <ac:graphicFrameMk id="4" creationId="{EEB50017-5EA1-F77E-BD93-BEC057B4F623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D7B05858-1D76-4AFF-A803-D85B778F61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Subtítol 2">
            <a:extLst>
              <a:ext uri="{FF2B5EF4-FFF2-40B4-BE49-F238E27FC236}">
                <a16:creationId xmlns:a16="http://schemas.microsoft.com/office/drawing/2014/main" id="{818AA968-2CD6-355B-4885-0A08D721B4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/>
              <a:t>Feu clic aquí per editar l'estil de subtítols del patró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35E7DB9A-247A-ABA4-380D-94BB04757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5188C876-2719-24CE-1B7F-1137CE16C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3A360DCA-B240-DB2E-6B9D-292ABFCC2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930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F614FC4C-47BC-D1DF-6CB0-8428FC25A2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9E358048-517C-EA00-54AC-F70876E57D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CB4409FD-4A96-5A2C-CF0C-1A6E7B160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1C169D7A-86BC-8284-DF15-160543D39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B63B638C-A3B3-6733-8EBD-F3E0308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2952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>
            <a:extLst>
              <a:ext uri="{FF2B5EF4-FFF2-40B4-BE49-F238E27FC236}">
                <a16:creationId xmlns:a16="http://schemas.microsoft.com/office/drawing/2014/main" id="{FDEF52AB-8828-FF42-13DB-356B48A629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CA986110-2225-7B5C-6EBE-57626FC23B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F3810EE8-EF2D-4F58-DFB3-7D4CB086C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773DD95D-B2E7-EB85-8015-E4AF5B170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CF50AD59-21EB-A1E1-0120-EE8BEBBF6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9587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872FF2A0-5C04-26C1-11BD-7252C7EA08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AE1321D7-3EB9-D01C-D575-F2C9124ED8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425769E4-968E-0DB9-8B66-2F5DB4F79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927E5045-D48C-87A4-0862-8A52C01700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6B0EF41B-14AA-ADF2-2F1B-D9531E5C7C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9181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CE872E8B-CB9C-2387-4DD7-0271E19C4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6FA64DC9-E7BC-87FB-9759-3E178F15FC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EE180F2A-EFEB-D543-B619-D88938AF5B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6FCAF532-62DF-D154-0173-1D99EF2FC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C9CE15A2-BA92-E386-66FD-EEB277E41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8513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57099990-09D9-36E4-3A89-731A78D47E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D4662416-D690-BD3E-8AB0-ECC70DAFF2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3B710095-F74D-EB96-3469-B0B80F9E0F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D95B5972-275D-DE37-165C-6693A9DCE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0BFE68DB-EE1D-E24F-418A-16D0C337D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ACA578DE-B77C-602A-7D29-11602DF03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376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EA0B85E6-3CDC-10E6-498A-A9A23A345F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2C6D238F-4028-EF94-F40A-3293228E06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5AA133CC-6C6F-B434-774E-54805CDBD9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text 4">
            <a:extLst>
              <a:ext uri="{FF2B5EF4-FFF2-40B4-BE49-F238E27FC236}">
                <a16:creationId xmlns:a16="http://schemas.microsoft.com/office/drawing/2014/main" id="{8691C94D-A1A1-F5E7-E9C9-17B18A7F47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6" name="Contenidor de contingut 5">
            <a:extLst>
              <a:ext uri="{FF2B5EF4-FFF2-40B4-BE49-F238E27FC236}">
                <a16:creationId xmlns:a16="http://schemas.microsoft.com/office/drawing/2014/main" id="{09CA2A8F-54BC-4267-E9F8-5449D318EA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7" name="Contenidor de data 6">
            <a:extLst>
              <a:ext uri="{FF2B5EF4-FFF2-40B4-BE49-F238E27FC236}">
                <a16:creationId xmlns:a16="http://schemas.microsoft.com/office/drawing/2014/main" id="{145F6C90-E397-3493-6F38-3E9663D714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8" name="Contenidor de peu de pàgina 7">
            <a:extLst>
              <a:ext uri="{FF2B5EF4-FFF2-40B4-BE49-F238E27FC236}">
                <a16:creationId xmlns:a16="http://schemas.microsoft.com/office/drawing/2014/main" id="{D6F06D6D-9B3D-6760-8D8A-9938A1F2E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Contenidor de número de diapositiva 8">
            <a:extLst>
              <a:ext uri="{FF2B5EF4-FFF2-40B4-BE49-F238E27FC236}">
                <a16:creationId xmlns:a16="http://schemas.microsoft.com/office/drawing/2014/main" id="{4321E83A-F168-F7F7-DD75-E56D37FF0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5689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CB1FA337-A099-3DB3-0E2B-159AC71C75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data 2">
            <a:extLst>
              <a:ext uri="{FF2B5EF4-FFF2-40B4-BE49-F238E27FC236}">
                <a16:creationId xmlns:a16="http://schemas.microsoft.com/office/drawing/2014/main" id="{22B8F77E-8DF6-2F9D-CB2D-8A870D4E6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4" name="Contenidor de peu de pàgina 3">
            <a:extLst>
              <a:ext uri="{FF2B5EF4-FFF2-40B4-BE49-F238E27FC236}">
                <a16:creationId xmlns:a16="http://schemas.microsoft.com/office/drawing/2014/main" id="{E3A28417-02CE-C978-9E27-2D8EEBFD0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Contenidor de número de diapositiva 4">
            <a:extLst>
              <a:ext uri="{FF2B5EF4-FFF2-40B4-BE49-F238E27FC236}">
                <a16:creationId xmlns:a16="http://schemas.microsoft.com/office/drawing/2014/main" id="{7233D062-3983-B83D-5DF6-32A198563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1227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>
            <a:extLst>
              <a:ext uri="{FF2B5EF4-FFF2-40B4-BE49-F238E27FC236}">
                <a16:creationId xmlns:a16="http://schemas.microsoft.com/office/drawing/2014/main" id="{6BD79AC4-5768-3338-2C49-E818E3E8D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3" name="Contenidor de peu de pàgina 2">
            <a:extLst>
              <a:ext uri="{FF2B5EF4-FFF2-40B4-BE49-F238E27FC236}">
                <a16:creationId xmlns:a16="http://schemas.microsoft.com/office/drawing/2014/main" id="{7FECF555-EB5F-726C-F29E-70ACE1944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Contenidor de número de diapositiva 3">
            <a:extLst>
              <a:ext uri="{FF2B5EF4-FFF2-40B4-BE49-F238E27FC236}">
                <a16:creationId xmlns:a16="http://schemas.microsoft.com/office/drawing/2014/main" id="{D2B328DF-80A9-6FC6-8BC7-63C22DE294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3986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4C863D1B-1D62-D51C-96E9-827A451384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CF3DA4A3-638E-2FB5-89EC-AB2F4D4156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9F62D0AB-D499-1E15-06D5-FCE087FA48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49BF4957-C68A-667C-6EEC-A4FF850015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512E45BE-29F9-1F7B-D0E6-24976CDC8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38BD5243-F3DB-20F1-0C2B-7B86C5750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1690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4C816183-F34A-D204-0F29-5324E450C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'imatge 2">
            <a:extLst>
              <a:ext uri="{FF2B5EF4-FFF2-40B4-BE49-F238E27FC236}">
                <a16:creationId xmlns:a16="http://schemas.microsoft.com/office/drawing/2014/main" id="{375D7FBF-A4AC-699E-3319-7A08C1F796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356F8E0B-BF44-490C-3B7B-91D2EC84E1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A9C3B4F6-2C83-897E-A142-A6FC55F37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0960C6C0-5D6F-39EA-21EA-7749A0909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2632E3A7-125A-5A34-8C15-B47F55C51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7400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>
            <a:extLst>
              <a:ext uri="{FF2B5EF4-FFF2-40B4-BE49-F238E27FC236}">
                <a16:creationId xmlns:a16="http://schemas.microsoft.com/office/drawing/2014/main" id="{AFBA57EA-9871-231F-C19E-F8A9EC7EBA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E368C1E1-32D6-82DF-B106-EFD7F59946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AF4219EA-1013-057D-585E-E907EA8BB6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1874F8-5220-4E59-8BDB-8DC9B3A4451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13EB29ED-1565-5A36-D5B0-FB378885B6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0EA2A155-49A0-3ABE-5B6D-EAD4F5B052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675133B-754F-41CC-BDEA-BC1969C0FB1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1624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e 3">
            <a:extLst>
              <a:ext uri="{FF2B5EF4-FFF2-40B4-BE49-F238E27FC236}">
                <a16:creationId xmlns:a16="http://schemas.microsoft.com/office/drawing/2014/main" id="{EEB50017-5EA1-F77E-BD93-BEC057B4F6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1892714"/>
              </p:ext>
            </p:extLst>
          </p:nvPr>
        </p:nvGraphicFramePr>
        <p:xfrm>
          <a:off x="3666112" y="1380983"/>
          <a:ext cx="4699169" cy="49971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829586" imgH="3008007" progId="Prism10.Document">
                  <p:embed/>
                </p:oleObj>
              </mc:Choice>
              <mc:Fallback>
                <p:oleObj name="Prism 10" r:id="rId2" imgW="2829586" imgH="3008007" progId="Prism10.Document">
                  <p:embed/>
                  <p:pic>
                    <p:nvPicPr>
                      <p:cNvPr id="4" name="Objecte 3">
                        <a:extLst>
                          <a:ext uri="{FF2B5EF4-FFF2-40B4-BE49-F238E27FC236}">
                            <a16:creationId xmlns:a16="http://schemas.microsoft.com/office/drawing/2014/main" id="{EEB50017-5EA1-F77E-BD93-BEC057B4F6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66112" y="1380983"/>
                        <a:ext cx="4699169" cy="49971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QuadreDeText 2">
            <a:extLst>
              <a:ext uri="{FF2B5EF4-FFF2-40B4-BE49-F238E27FC236}">
                <a16:creationId xmlns:a16="http://schemas.microsoft.com/office/drawing/2014/main" id="{F3C2BABC-2B76-A0CE-EE7E-FF586944F832}"/>
              </a:ext>
            </a:extLst>
          </p:cNvPr>
          <p:cNvSpPr txBox="1"/>
          <p:nvPr/>
        </p:nvSpPr>
        <p:spPr>
          <a:xfrm>
            <a:off x="504826" y="281982"/>
            <a:ext cx="1151572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 8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equenci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FN-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 per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l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BMC at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mologou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ru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rcil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V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non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non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V/Ch = no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or =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rcil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R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L = Innovac 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* = p&lt;0.05; ** = p&lt;0.01; *** = p&lt;0.001.</a:t>
            </a:r>
          </a:p>
        </p:txBody>
      </p:sp>
    </p:spTree>
    <p:extLst>
      <p:ext uri="{BB962C8B-B14F-4D97-AF65-F5344CB8AC3E}">
        <p14:creationId xmlns:p14="http://schemas.microsoft.com/office/powerpoint/2010/main" val="23058134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icin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4</Words>
  <Application>Microsoft Office PowerPoint</Application>
  <PresentationFormat>Pantalla panoràmica</PresentationFormat>
  <Paragraphs>1</Paragraphs>
  <Slides>1</Slides>
  <Notes>0</Notes>
  <HiddenSlides>0</HiddenSlides>
  <MMClips>0</MMClips>
  <ScaleCrop>false</ScaleCrop>
  <HeadingPairs>
    <vt:vector size="8" baseType="variant">
      <vt:variant>
        <vt:lpstr>Tipus de lletra utilitzats</vt:lpstr>
      </vt:variant>
      <vt:variant>
        <vt:i4>4</vt:i4>
      </vt:variant>
      <vt:variant>
        <vt:lpstr>Tema</vt:lpstr>
      </vt:variant>
      <vt:variant>
        <vt:i4>1</vt:i4>
      </vt:variant>
      <vt:variant>
        <vt:lpstr>Servidors OLE incrustats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Tema de l'Office</vt:lpstr>
      <vt:lpstr>Prism 10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nrique María Mateu de Antonio</dc:creator>
  <cp:lastModifiedBy>Enrique María Mateu de Antonio</cp:lastModifiedBy>
  <cp:revision>1</cp:revision>
  <dcterms:created xsi:type="dcterms:W3CDTF">2025-02-28T12:05:45Z</dcterms:created>
  <dcterms:modified xsi:type="dcterms:W3CDTF">2025-04-22T12:48:23Z</dcterms:modified>
</cp:coreProperties>
</file>